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539"/>
    <p:restoredTop sz="99306" autoAdjust="0"/>
  </p:normalViewPr>
  <p:slideViewPr>
    <p:cSldViewPr snapToGrid="0">
      <p:cViewPr varScale="1">
        <p:scale>
          <a:sx n="146" d="100"/>
          <a:sy n="146" d="100"/>
        </p:scale>
        <p:origin x="1696" y="1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microsoft.com/office/2011/relationships/chartStyle" Target="style7.xml"/><Relationship Id="rId2" Type="http://schemas.microsoft.com/office/2011/relationships/chartColorStyle" Target="colors7.xml"/><Relationship Id="rId3" Type="http://schemas.openxmlformats.org/officeDocument/2006/relationships/oleObject" Target="file:////Volumes/group09/Carrie/Breast%20Cancer%20project/Carrie's%20Data/Western%20blots/Jana%20Eli%20blots/requant%20and%20standard%20error_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microsoft.com/office/2011/relationships/chartStyle" Target="style8.xml"/><Relationship Id="rId2" Type="http://schemas.microsoft.com/office/2011/relationships/chartColorStyle" Target="colors8.xml"/><Relationship Id="rId3" Type="http://schemas.openxmlformats.org/officeDocument/2006/relationships/oleObject" Target="file:////Volumes/Group09/TGS/Carrie/Breast%20Cancer%20project/Carrie's%20Data/Western%20blots/LiCor/Ikkbi%20time%20course/quantit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IKKe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1383578801093"/>
          <c:y val="0.229488512622884"/>
          <c:w val="0.80314765548577"/>
          <c:h val="0.5835578878581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AP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Y$53:$Z$53</c:f>
                <c:numCache>
                  <c:formatCode>General</c:formatCode>
                  <c:ptCount val="2"/>
                  <c:pt idx="0">
                    <c:v>0.0492213049046573</c:v>
                  </c:pt>
                  <c:pt idx="1">
                    <c:v>0.0896174683859488</c:v>
                  </c:pt>
                </c:numCache>
              </c:numRef>
            </c:plus>
            <c:minus>
              <c:numRef>
                <c:f>Treated!$Y$53:$Z$53</c:f>
                <c:numCache>
                  <c:formatCode>General</c:formatCode>
                  <c:ptCount val="2"/>
                  <c:pt idx="0">
                    <c:v>0.0492213049046573</c:v>
                  </c:pt>
                  <c:pt idx="1">
                    <c:v>0.089617468385948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Q$43:$AR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Q$44:$AR$44</c:f>
              <c:numCache>
                <c:formatCode>General</c:formatCode>
                <c:ptCount val="2"/>
                <c:pt idx="0">
                  <c:v>0.832071222284418</c:v>
                </c:pt>
                <c:pt idx="1">
                  <c:v>1.1971199266280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666-3F4E-BA56-5BC0F64465B5}"/>
            </c:ext>
          </c:extLst>
        </c:ser>
        <c:ser>
          <c:idx val="1"/>
          <c:order val="1"/>
          <c:tx>
            <c:strRef>
              <c:f>Treated!$AP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Y$54:$Z$54</c:f>
                <c:numCache>
                  <c:formatCode>General</c:formatCode>
                  <c:ptCount val="2"/>
                  <c:pt idx="0">
                    <c:v>0.0673759235943579</c:v>
                  </c:pt>
                  <c:pt idx="1">
                    <c:v>0.352693947628387</c:v>
                  </c:pt>
                </c:numCache>
              </c:numRef>
            </c:plus>
            <c:minus>
              <c:numRef>
                <c:f>Treated!$Y$54:$Z$54</c:f>
                <c:numCache>
                  <c:formatCode>General</c:formatCode>
                  <c:ptCount val="2"/>
                  <c:pt idx="0">
                    <c:v>0.0673759235943579</c:v>
                  </c:pt>
                  <c:pt idx="1">
                    <c:v>0.35269394762838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Q$43:$AR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Q$45:$AR$45</c:f>
              <c:numCache>
                <c:formatCode>General</c:formatCode>
                <c:ptCount val="2"/>
                <c:pt idx="0">
                  <c:v>0.656193936923979</c:v>
                </c:pt>
                <c:pt idx="1">
                  <c:v>1.5657343288437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666-3F4E-BA56-5BC0F64465B5}"/>
            </c:ext>
          </c:extLst>
        </c:ser>
        <c:ser>
          <c:idx val="2"/>
          <c:order val="2"/>
          <c:tx>
            <c:strRef>
              <c:f>Treated!$AP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Y$55:$Z$55</c:f>
                <c:numCache>
                  <c:formatCode>General</c:formatCode>
                  <c:ptCount val="2"/>
                  <c:pt idx="0">
                    <c:v>0.216292054025193</c:v>
                  </c:pt>
                  <c:pt idx="1">
                    <c:v>0.284126911659319</c:v>
                  </c:pt>
                </c:numCache>
              </c:numRef>
            </c:plus>
            <c:minus>
              <c:numRef>
                <c:f>Treated!$Y$55:$Z$55</c:f>
                <c:numCache>
                  <c:formatCode>General</c:formatCode>
                  <c:ptCount val="2"/>
                  <c:pt idx="0">
                    <c:v>0.216292054025193</c:v>
                  </c:pt>
                  <c:pt idx="1">
                    <c:v>0.2841269116593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Q$43:$AR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Q$46:$AR$46</c:f>
              <c:numCache>
                <c:formatCode>General</c:formatCode>
                <c:ptCount val="2"/>
                <c:pt idx="0">
                  <c:v>0.577777292351565</c:v>
                </c:pt>
                <c:pt idx="1">
                  <c:v>1.37737448267040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1666-3F4E-BA56-5BC0F64465B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14556624"/>
        <c:axId val="-423168096"/>
      </c:barChart>
      <c:catAx>
        <c:axId val="-414556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23168096"/>
        <c:crosses val="autoZero"/>
        <c:auto val="1"/>
        <c:lblAlgn val="ctr"/>
        <c:lblOffset val="100"/>
        <c:noMultiLvlLbl val="0"/>
      </c:catAx>
      <c:valAx>
        <c:axId val="-423168096"/>
        <c:scaling>
          <c:orientation val="minMax"/>
          <c:max val="2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45566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p100</a:t>
            </a:r>
          </a:p>
        </c:rich>
      </c:tx>
      <c:layout>
        <c:manualLayout>
          <c:xMode val="edge"/>
          <c:yMode val="edge"/>
          <c:x val="0.441968684327584"/>
          <c:y val="0.020206054020169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51329486672157"/>
          <c:y val="0.213729403937224"/>
          <c:w val="0.775097325162298"/>
          <c:h val="0.5993006206696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AT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A$53:$AB$53</c:f>
                <c:numCache>
                  <c:formatCode>General</c:formatCode>
                  <c:ptCount val="2"/>
                  <c:pt idx="0">
                    <c:v>0.132847730550134</c:v>
                  </c:pt>
                  <c:pt idx="1">
                    <c:v>0.113455671513827</c:v>
                  </c:pt>
                </c:numCache>
              </c:numRef>
            </c:plus>
            <c:minus>
              <c:numRef>
                <c:f>Treated!$AA$53:$AB$53</c:f>
                <c:numCache>
                  <c:formatCode>General</c:formatCode>
                  <c:ptCount val="2"/>
                  <c:pt idx="0">
                    <c:v>0.132847730550134</c:v>
                  </c:pt>
                  <c:pt idx="1">
                    <c:v>0.11345567151382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U$43:$AV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U$44:$AV$44</c:f>
              <c:numCache>
                <c:formatCode>General</c:formatCode>
                <c:ptCount val="2"/>
                <c:pt idx="0">
                  <c:v>1.180554996858811</c:v>
                </c:pt>
                <c:pt idx="1">
                  <c:v>1.01361094567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258-A94A-9E36-38D660E87AFB}"/>
            </c:ext>
          </c:extLst>
        </c:ser>
        <c:ser>
          <c:idx val="1"/>
          <c:order val="1"/>
          <c:tx>
            <c:strRef>
              <c:f>Treated!$AT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A$54:$AB$54</c:f>
                <c:numCache>
                  <c:formatCode>General</c:formatCode>
                  <c:ptCount val="2"/>
                  <c:pt idx="0">
                    <c:v>0.0101518193562112</c:v>
                  </c:pt>
                  <c:pt idx="1">
                    <c:v>0.206596553783875</c:v>
                  </c:pt>
                </c:numCache>
              </c:numRef>
            </c:plus>
            <c:minus>
              <c:numRef>
                <c:f>Treated!$AA$54:$AB$54</c:f>
                <c:numCache>
                  <c:formatCode>General</c:formatCode>
                  <c:ptCount val="2"/>
                  <c:pt idx="0">
                    <c:v>0.0101518193562112</c:v>
                  </c:pt>
                  <c:pt idx="1">
                    <c:v>0.2065965537838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U$43:$AV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U$45:$AV$45</c:f>
              <c:numCache>
                <c:formatCode>General</c:formatCode>
                <c:ptCount val="2"/>
                <c:pt idx="0">
                  <c:v>0.682850517947158</c:v>
                </c:pt>
                <c:pt idx="1">
                  <c:v>0.82501140713371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258-A94A-9E36-38D660E87AFB}"/>
            </c:ext>
          </c:extLst>
        </c:ser>
        <c:ser>
          <c:idx val="2"/>
          <c:order val="2"/>
          <c:tx>
            <c:strRef>
              <c:f>Treated!$AT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A$55:$AB$55</c:f>
                <c:numCache>
                  <c:formatCode>General</c:formatCode>
                  <c:ptCount val="2"/>
                  <c:pt idx="0">
                    <c:v>0.0380315416236406</c:v>
                  </c:pt>
                  <c:pt idx="1">
                    <c:v>0.135477349180891</c:v>
                  </c:pt>
                </c:numCache>
              </c:numRef>
            </c:plus>
            <c:minus>
              <c:numRef>
                <c:f>Treated!$AA$55:$AB$55</c:f>
                <c:numCache>
                  <c:formatCode>General</c:formatCode>
                  <c:ptCount val="2"/>
                  <c:pt idx="0">
                    <c:v>0.0380315416236406</c:v>
                  </c:pt>
                  <c:pt idx="1">
                    <c:v>0.1354773491808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U$43:$AV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U$46:$AV$46</c:f>
              <c:numCache>
                <c:formatCode>General</c:formatCode>
                <c:ptCount val="2"/>
                <c:pt idx="0">
                  <c:v>1.406667650286615</c:v>
                </c:pt>
                <c:pt idx="1">
                  <c:v>1.39924839670748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258-A94A-9E36-38D660E87AF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49530032"/>
        <c:axId val="-878861328"/>
      </c:barChart>
      <c:catAx>
        <c:axId val="-549530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78861328"/>
        <c:crosses val="autoZero"/>
        <c:auto val="1"/>
        <c:lblAlgn val="ctr"/>
        <c:lblOffset val="100"/>
        <c:noMultiLvlLbl val="0"/>
      </c:catAx>
      <c:valAx>
        <c:axId val="-87886132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953003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p52</a:t>
            </a:r>
          </a:p>
        </c:rich>
      </c:tx>
      <c:layout>
        <c:manualLayout>
          <c:xMode val="edge"/>
          <c:yMode val="edge"/>
          <c:x val="0.447444679416814"/>
          <c:y val="0.04662007550411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19274238856987"/>
          <c:y val="0.204835585128119"/>
          <c:w val="0.802843663600285"/>
          <c:h val="0.60451878975496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AX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C$53:$AD$53</c:f>
                <c:numCache>
                  <c:formatCode>General</c:formatCode>
                  <c:ptCount val="2"/>
                  <c:pt idx="0">
                    <c:v>0.0187535180439951</c:v>
                  </c:pt>
                  <c:pt idx="1">
                    <c:v>0.24652726158475</c:v>
                  </c:pt>
                </c:numCache>
              </c:numRef>
            </c:plus>
            <c:minus>
              <c:numRef>
                <c:f>Treated!$AC$53:$AD$53</c:f>
                <c:numCache>
                  <c:formatCode>General</c:formatCode>
                  <c:ptCount val="2"/>
                  <c:pt idx="0">
                    <c:v>0.0187535180439951</c:v>
                  </c:pt>
                  <c:pt idx="1">
                    <c:v>0.246527261584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Y$43:$AZ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Y$44:$AZ$44</c:f>
              <c:numCache>
                <c:formatCode>General</c:formatCode>
                <c:ptCount val="2"/>
                <c:pt idx="0">
                  <c:v>1.035516365556507</c:v>
                </c:pt>
                <c:pt idx="1">
                  <c:v>0.95503419635216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2B0-AD41-AAD4-AF3506ACA743}"/>
            </c:ext>
          </c:extLst>
        </c:ser>
        <c:ser>
          <c:idx val="1"/>
          <c:order val="1"/>
          <c:tx>
            <c:strRef>
              <c:f>Treated!$AX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C$54:$AD$54</c:f>
                <c:numCache>
                  <c:formatCode>General</c:formatCode>
                  <c:ptCount val="2"/>
                  <c:pt idx="0">
                    <c:v>0.0950157521058934</c:v>
                  </c:pt>
                  <c:pt idx="1">
                    <c:v>0.376871347789516</c:v>
                  </c:pt>
                </c:numCache>
              </c:numRef>
            </c:plus>
            <c:minus>
              <c:numRef>
                <c:f>Treated!$AC$54:$AD$54</c:f>
                <c:numCache>
                  <c:formatCode>General</c:formatCode>
                  <c:ptCount val="2"/>
                  <c:pt idx="0">
                    <c:v>0.0950157521058934</c:v>
                  </c:pt>
                  <c:pt idx="1">
                    <c:v>0.3768713477895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Y$43:$AZ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Y$45:$AZ$45</c:f>
              <c:numCache>
                <c:formatCode>General</c:formatCode>
                <c:ptCount val="2"/>
                <c:pt idx="0">
                  <c:v>0.664575144438656</c:v>
                </c:pt>
                <c:pt idx="1">
                  <c:v>1.0646731567186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2B0-AD41-AAD4-AF3506ACA743}"/>
            </c:ext>
          </c:extLst>
        </c:ser>
        <c:ser>
          <c:idx val="2"/>
          <c:order val="2"/>
          <c:tx>
            <c:strRef>
              <c:f>Treated!$AX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C$55:$AD$55</c:f>
                <c:numCache>
                  <c:formatCode>General</c:formatCode>
                  <c:ptCount val="2"/>
                  <c:pt idx="0">
                    <c:v>0.17358941110686</c:v>
                  </c:pt>
                  <c:pt idx="1">
                    <c:v>0.243577562659257</c:v>
                  </c:pt>
                </c:numCache>
              </c:numRef>
            </c:plus>
            <c:minus>
              <c:numRef>
                <c:f>Treated!$AC$55:$AD$55</c:f>
                <c:numCache>
                  <c:formatCode>General</c:formatCode>
                  <c:ptCount val="2"/>
                  <c:pt idx="0">
                    <c:v>0.17358941110686</c:v>
                  </c:pt>
                  <c:pt idx="1">
                    <c:v>0.24357756265925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AY$43:$AZ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AY$46:$AZ$46</c:f>
              <c:numCache>
                <c:formatCode>General</c:formatCode>
                <c:ptCount val="2"/>
                <c:pt idx="0">
                  <c:v>0.930970270692626</c:v>
                </c:pt>
                <c:pt idx="1">
                  <c:v>1.38715584909797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52B0-AD41-AAD4-AF3506ACA74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53531424"/>
        <c:axId val="-519953216"/>
      </c:barChart>
      <c:catAx>
        <c:axId val="-553531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19953216"/>
        <c:crosses val="autoZero"/>
        <c:auto val="1"/>
        <c:lblAlgn val="ctr"/>
        <c:lblOffset val="100"/>
        <c:noMultiLvlLbl val="0"/>
      </c:catAx>
      <c:valAx>
        <c:axId val="-51995321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5353142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phospho p65</a:t>
            </a:r>
          </a:p>
        </c:rich>
      </c:tx>
      <c:layout>
        <c:manualLayout>
          <c:xMode val="edge"/>
          <c:yMode val="edge"/>
          <c:x val="0.347906541304165"/>
          <c:y val="0.063408965566102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36653080852962"/>
          <c:y val="0.237661524202377"/>
          <c:w val="0.777151513821691"/>
          <c:h val="0.57587401344545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BF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G$53:$AH$53</c:f>
                <c:numCache>
                  <c:formatCode>General</c:formatCode>
                  <c:ptCount val="2"/>
                  <c:pt idx="0">
                    <c:v>0.153948088257754</c:v>
                  </c:pt>
                  <c:pt idx="1">
                    <c:v>0.0890132876246968</c:v>
                  </c:pt>
                </c:numCache>
              </c:numRef>
            </c:plus>
            <c:minus>
              <c:numRef>
                <c:f>Treated!$AG$53:$AH$53</c:f>
                <c:numCache>
                  <c:formatCode>General</c:formatCode>
                  <c:ptCount val="2"/>
                  <c:pt idx="0">
                    <c:v>0.153948088257754</c:v>
                  </c:pt>
                  <c:pt idx="1">
                    <c:v>0.08901328762469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G$43:$BH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G$44:$BH$44</c:f>
              <c:numCache>
                <c:formatCode>General</c:formatCode>
                <c:ptCount val="2"/>
                <c:pt idx="0">
                  <c:v>1.020374282669094</c:v>
                </c:pt>
                <c:pt idx="1">
                  <c:v>1.00412232408423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5DE-8C4A-8FCC-465EE122786F}"/>
            </c:ext>
          </c:extLst>
        </c:ser>
        <c:ser>
          <c:idx val="1"/>
          <c:order val="1"/>
          <c:tx>
            <c:strRef>
              <c:f>Treated!$BF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G$54:$AH$54</c:f>
                <c:numCache>
                  <c:formatCode>General</c:formatCode>
                  <c:ptCount val="2"/>
                  <c:pt idx="0">
                    <c:v>0.0899497264582995</c:v>
                  </c:pt>
                  <c:pt idx="1">
                    <c:v>0.025171123195538</c:v>
                  </c:pt>
                </c:numCache>
              </c:numRef>
            </c:plus>
            <c:minus>
              <c:numRef>
                <c:f>Treated!$AG$54:$AH$54</c:f>
                <c:numCache>
                  <c:formatCode>General</c:formatCode>
                  <c:ptCount val="2"/>
                  <c:pt idx="0">
                    <c:v>0.0899497264582995</c:v>
                  </c:pt>
                  <c:pt idx="1">
                    <c:v>0.02517112319553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G$43:$BH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G$45:$BH$45</c:f>
              <c:numCache>
                <c:formatCode>General</c:formatCode>
                <c:ptCount val="2"/>
                <c:pt idx="0">
                  <c:v>0.403968762972658</c:v>
                </c:pt>
                <c:pt idx="1">
                  <c:v>0.67141934016449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5DE-8C4A-8FCC-465EE122786F}"/>
            </c:ext>
          </c:extLst>
        </c:ser>
        <c:ser>
          <c:idx val="2"/>
          <c:order val="2"/>
          <c:tx>
            <c:strRef>
              <c:f>Treated!$BF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G$55:$AH$55</c:f>
                <c:numCache>
                  <c:formatCode>General</c:formatCode>
                  <c:ptCount val="2"/>
                  <c:pt idx="0">
                    <c:v>0.34177454101427</c:v>
                  </c:pt>
                  <c:pt idx="1">
                    <c:v>0.232447130194453</c:v>
                  </c:pt>
                </c:numCache>
              </c:numRef>
            </c:plus>
            <c:minus>
              <c:numRef>
                <c:f>Treated!$AG$55:$AH$55</c:f>
                <c:numCache>
                  <c:formatCode>General</c:formatCode>
                  <c:ptCount val="2"/>
                  <c:pt idx="0">
                    <c:v>0.34177454101427</c:v>
                  </c:pt>
                  <c:pt idx="1">
                    <c:v>0.23244713019445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G$43:$BH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G$46:$BH$46</c:f>
              <c:numCache>
                <c:formatCode>General</c:formatCode>
                <c:ptCount val="2"/>
                <c:pt idx="0">
                  <c:v>1.030503560257667</c:v>
                </c:pt>
                <c:pt idx="1">
                  <c:v>1.3045866375411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5DE-8C4A-8FCC-465EE122786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25647968"/>
        <c:axId val="-616209808"/>
      </c:barChart>
      <c:catAx>
        <c:axId val="-4256479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616209808"/>
        <c:crosses val="autoZero"/>
        <c:auto val="1"/>
        <c:lblAlgn val="ctr"/>
        <c:lblOffset val="100"/>
        <c:noMultiLvlLbl val="0"/>
      </c:catAx>
      <c:valAx>
        <c:axId val="-6162098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25647968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Total p65</a:t>
            </a:r>
          </a:p>
        </c:rich>
      </c:tx>
      <c:layout>
        <c:manualLayout>
          <c:xMode val="edge"/>
          <c:yMode val="edge"/>
          <c:x val="0.368609278832714"/>
          <c:y val="0.0293963789216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6348261163052"/>
          <c:y val="0.203181234386688"/>
          <c:w val="0.75277674091883"/>
          <c:h val="0.61982790660475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BJ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I$53:$AJ$53</c:f>
                <c:numCache>
                  <c:formatCode>General</c:formatCode>
                  <c:ptCount val="2"/>
                  <c:pt idx="0">
                    <c:v>0.191644531195307</c:v>
                  </c:pt>
                  <c:pt idx="1">
                    <c:v>0.0488134688873401</c:v>
                  </c:pt>
                </c:numCache>
              </c:numRef>
            </c:plus>
            <c:minus>
              <c:numRef>
                <c:f>Treated!$AI$53:$AJ$53</c:f>
                <c:numCache>
                  <c:formatCode>General</c:formatCode>
                  <c:ptCount val="2"/>
                  <c:pt idx="0">
                    <c:v>0.191644531195307</c:v>
                  </c:pt>
                  <c:pt idx="1">
                    <c:v>0.04881346888734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K$43:$BL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K$44:$BL$44</c:f>
              <c:numCache>
                <c:formatCode>General</c:formatCode>
                <c:ptCount val="2"/>
                <c:pt idx="0">
                  <c:v>1.11841023627594</c:v>
                </c:pt>
                <c:pt idx="1">
                  <c:v>0.9949783210570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CE51-2848-B7B6-1A753FE19D61}"/>
            </c:ext>
          </c:extLst>
        </c:ser>
        <c:ser>
          <c:idx val="1"/>
          <c:order val="1"/>
          <c:tx>
            <c:strRef>
              <c:f>Treated!$BJ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I$54:$AJ$54</c:f>
                <c:numCache>
                  <c:formatCode>General</c:formatCode>
                  <c:ptCount val="2"/>
                  <c:pt idx="0">
                    <c:v>0.198502482684782</c:v>
                  </c:pt>
                  <c:pt idx="1">
                    <c:v>0.170482922283179</c:v>
                  </c:pt>
                </c:numCache>
              </c:numRef>
            </c:plus>
            <c:minus>
              <c:numRef>
                <c:f>Treated!$AI$54:$AJ$54</c:f>
                <c:numCache>
                  <c:formatCode>General</c:formatCode>
                  <c:ptCount val="2"/>
                  <c:pt idx="0">
                    <c:v>0.198502482684782</c:v>
                  </c:pt>
                  <c:pt idx="1">
                    <c:v>0.1704829222831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K$43:$BL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K$45:$BL$45</c:f>
              <c:numCache>
                <c:formatCode>General</c:formatCode>
                <c:ptCount val="2"/>
                <c:pt idx="0">
                  <c:v>0.57881349321329</c:v>
                </c:pt>
                <c:pt idx="1">
                  <c:v>1.0665608595148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CE51-2848-B7B6-1A753FE19D61}"/>
            </c:ext>
          </c:extLst>
        </c:ser>
        <c:ser>
          <c:idx val="2"/>
          <c:order val="2"/>
          <c:tx>
            <c:strRef>
              <c:f>Treated!$BJ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I$55:$AJ$55</c:f>
                <c:numCache>
                  <c:formatCode>General</c:formatCode>
                  <c:ptCount val="2"/>
                  <c:pt idx="0">
                    <c:v>0.13156909198897</c:v>
                  </c:pt>
                  <c:pt idx="1">
                    <c:v>0.351558280791844</c:v>
                  </c:pt>
                </c:numCache>
              </c:numRef>
            </c:plus>
            <c:minus>
              <c:numRef>
                <c:f>Treated!$AI$55:$AJ$55</c:f>
                <c:numCache>
                  <c:formatCode>General</c:formatCode>
                  <c:ptCount val="2"/>
                  <c:pt idx="0">
                    <c:v>0.13156909198897</c:v>
                  </c:pt>
                  <c:pt idx="1">
                    <c:v>0.35155828079184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K$43:$BL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K$46:$BL$46</c:f>
              <c:numCache>
                <c:formatCode>General</c:formatCode>
                <c:ptCount val="2"/>
                <c:pt idx="0">
                  <c:v>0.638852777123096</c:v>
                </c:pt>
                <c:pt idx="1">
                  <c:v>1.59918873373045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CE51-2848-B7B6-1A753FE19D6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15159504"/>
        <c:axId val="-414588768"/>
      </c:barChart>
      <c:catAx>
        <c:axId val="-4151595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4588768"/>
        <c:crosses val="autoZero"/>
        <c:auto val="1"/>
        <c:lblAlgn val="ctr"/>
        <c:lblOffset val="100"/>
        <c:noMultiLvlLbl val="0"/>
      </c:catAx>
      <c:valAx>
        <c:axId val="-414588768"/>
        <c:scaling>
          <c:orientation val="minMax"/>
          <c:max val="2.0"/>
          <c:min val="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5159504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phospho ERK</a:t>
            </a:r>
          </a:p>
        </c:rich>
      </c:tx>
      <c:layout>
        <c:manualLayout>
          <c:xMode val="edge"/>
          <c:yMode val="edge"/>
          <c:x val="0.350569918748468"/>
          <c:y val="0.041359551426058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68050230929453"/>
          <c:y val="0.217563732684465"/>
          <c:w val="0.750247309534543"/>
          <c:h val="0.5602481684143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BN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K$53:$AL$53</c:f>
                <c:numCache>
                  <c:formatCode>General</c:formatCode>
                  <c:ptCount val="2"/>
                  <c:pt idx="0">
                    <c:v>0.00860889616054032</c:v>
                  </c:pt>
                  <c:pt idx="1">
                    <c:v>0.0202985136208095</c:v>
                  </c:pt>
                </c:numCache>
              </c:numRef>
            </c:plus>
            <c:minus>
              <c:numRef>
                <c:f>Treated!$AK$53:$AL$53</c:f>
                <c:numCache>
                  <c:formatCode>General</c:formatCode>
                  <c:ptCount val="2"/>
                  <c:pt idx="0">
                    <c:v>0.00860889616054032</c:v>
                  </c:pt>
                  <c:pt idx="1">
                    <c:v>0.020298513620809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O$43:$BP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O$44:$BP$44</c:f>
              <c:numCache>
                <c:formatCode>General</c:formatCode>
                <c:ptCount val="2"/>
                <c:pt idx="0">
                  <c:v>0.052519178204674</c:v>
                </c:pt>
                <c:pt idx="1">
                  <c:v>0.040891604863184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225-594A-A3EA-FB90B2169F73}"/>
            </c:ext>
          </c:extLst>
        </c:ser>
        <c:ser>
          <c:idx val="1"/>
          <c:order val="1"/>
          <c:tx>
            <c:strRef>
              <c:f>Treated!$BN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K$54:$AL$54</c:f>
                <c:numCache>
                  <c:formatCode>General</c:formatCode>
                  <c:ptCount val="2"/>
                  <c:pt idx="0">
                    <c:v>0.0594769503736835</c:v>
                  </c:pt>
                  <c:pt idx="1">
                    <c:v>0.190069996959033</c:v>
                  </c:pt>
                </c:numCache>
              </c:numRef>
            </c:plus>
            <c:minus>
              <c:numRef>
                <c:f>Treated!$AK$54:$AL$54</c:f>
                <c:numCache>
                  <c:formatCode>General</c:formatCode>
                  <c:ptCount val="2"/>
                  <c:pt idx="0">
                    <c:v>0.0594769503736835</c:v>
                  </c:pt>
                  <c:pt idx="1">
                    <c:v>0.1900699969590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O$43:$BP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O$45:$BP$45</c:f>
              <c:numCache>
                <c:formatCode>General</c:formatCode>
                <c:ptCount val="2"/>
                <c:pt idx="0">
                  <c:v>0.852120087233459</c:v>
                </c:pt>
                <c:pt idx="1">
                  <c:v>0.6723072795474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225-594A-A3EA-FB90B2169F73}"/>
            </c:ext>
          </c:extLst>
        </c:ser>
        <c:ser>
          <c:idx val="2"/>
          <c:order val="2"/>
          <c:tx>
            <c:strRef>
              <c:f>Treated!$BN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K$55:$AL$55</c:f>
                <c:numCache>
                  <c:formatCode>General</c:formatCode>
                  <c:ptCount val="2"/>
                  <c:pt idx="0">
                    <c:v>0.0374399509444636</c:v>
                  </c:pt>
                  <c:pt idx="1">
                    <c:v>0.472414239237851</c:v>
                  </c:pt>
                </c:numCache>
              </c:numRef>
            </c:plus>
            <c:minus>
              <c:numRef>
                <c:f>Treated!$AK$55:$AL$55</c:f>
                <c:numCache>
                  <c:formatCode>General</c:formatCode>
                  <c:ptCount val="2"/>
                  <c:pt idx="0">
                    <c:v>0.0374399509444636</c:v>
                  </c:pt>
                  <c:pt idx="1">
                    <c:v>0.47241423923785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O$43:$BP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O$46:$BP$46</c:f>
              <c:numCache>
                <c:formatCode>General</c:formatCode>
                <c:ptCount val="2"/>
                <c:pt idx="0">
                  <c:v>1.410979761576543</c:v>
                </c:pt>
                <c:pt idx="1">
                  <c:v>1.56460352714123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E225-594A-A3EA-FB90B2169F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415009056"/>
        <c:axId val="-423288032"/>
      </c:barChart>
      <c:catAx>
        <c:axId val="-4150090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23288032"/>
        <c:crosses val="autoZero"/>
        <c:auto val="1"/>
        <c:lblAlgn val="ctr"/>
        <c:lblOffset val="100"/>
        <c:noMultiLvlLbl val="0"/>
      </c:catAx>
      <c:valAx>
        <c:axId val="-423288032"/>
        <c:scaling>
          <c:orientation val="minMax"/>
          <c:max val="2.5"/>
          <c:min val="0.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0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415009056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000" b="0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1000"/>
              <a:t>Total ERK</a:t>
            </a:r>
          </a:p>
        </c:rich>
      </c:tx>
      <c:layout>
        <c:manualLayout>
          <c:xMode val="edge"/>
          <c:yMode val="edge"/>
          <c:x val="0.371065452783036"/>
          <c:y val="0.04572832621363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21212266482325"/>
          <c:y val="0.203079856780323"/>
          <c:w val="0.799640168611638"/>
          <c:h val="0.58018371985171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Treated!$BR$44</c:f>
              <c:strCache>
                <c:ptCount val="1"/>
                <c:pt idx="0">
                  <c:v>MEK Inhibitor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M$53:$AN$53</c:f>
                <c:numCache>
                  <c:formatCode>General</c:formatCode>
                  <c:ptCount val="2"/>
                  <c:pt idx="0">
                    <c:v>0.268892134792665</c:v>
                  </c:pt>
                  <c:pt idx="1">
                    <c:v>0.0942130898321799</c:v>
                  </c:pt>
                </c:numCache>
              </c:numRef>
            </c:plus>
            <c:minus>
              <c:numRef>
                <c:f>Treated!$AM$53:$AN$53</c:f>
                <c:numCache>
                  <c:formatCode>General</c:formatCode>
                  <c:ptCount val="2"/>
                  <c:pt idx="0">
                    <c:v>0.268892134792665</c:v>
                  </c:pt>
                  <c:pt idx="1">
                    <c:v>0.09421308983217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S$43:$BT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S$44:$BT$44</c:f>
              <c:numCache>
                <c:formatCode>General</c:formatCode>
                <c:ptCount val="2"/>
                <c:pt idx="0">
                  <c:v>0.904986849614511</c:v>
                </c:pt>
                <c:pt idx="1">
                  <c:v>1.1339101055298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E8C-6149-97D8-5351880A8F69}"/>
            </c:ext>
          </c:extLst>
        </c:ser>
        <c:ser>
          <c:idx val="1"/>
          <c:order val="1"/>
          <c:tx>
            <c:strRef>
              <c:f>Treated!$BR$45</c:f>
              <c:strCache>
                <c:ptCount val="1"/>
                <c:pt idx="0">
                  <c:v>IKKB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M$54:$AN$54</c:f>
                <c:numCache>
                  <c:formatCode>General</c:formatCode>
                  <c:ptCount val="2"/>
                  <c:pt idx="0">
                    <c:v>0.11943977447596</c:v>
                  </c:pt>
                  <c:pt idx="1">
                    <c:v>0.298688284201168</c:v>
                  </c:pt>
                </c:numCache>
              </c:numRef>
            </c:plus>
            <c:minus>
              <c:numRef>
                <c:f>Treated!$AM$54:$AN$54</c:f>
                <c:numCache>
                  <c:formatCode>General</c:formatCode>
                  <c:ptCount val="2"/>
                  <c:pt idx="0">
                    <c:v>0.11943977447596</c:v>
                  </c:pt>
                  <c:pt idx="1">
                    <c:v>0.2986882842011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S$43:$BT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S$45:$BT$45</c:f>
              <c:numCache>
                <c:formatCode>General</c:formatCode>
                <c:ptCount val="2"/>
                <c:pt idx="0">
                  <c:v>0.646844694370095</c:v>
                </c:pt>
                <c:pt idx="1">
                  <c:v>1.19374002292555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E8C-6149-97D8-5351880A8F69}"/>
            </c:ext>
          </c:extLst>
        </c:ser>
        <c:ser>
          <c:idx val="2"/>
          <c:order val="2"/>
          <c:tx>
            <c:strRef>
              <c:f>Treated!$BR$46</c:f>
              <c:strCache>
                <c:ptCount val="1"/>
                <c:pt idx="0">
                  <c:v>IKKE Inhibitor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Treated!$AM$55:$AN$55</c:f>
                <c:numCache>
                  <c:formatCode>General</c:formatCode>
                  <c:ptCount val="2"/>
                  <c:pt idx="0">
                    <c:v>0.150191942173496</c:v>
                  </c:pt>
                  <c:pt idx="1">
                    <c:v>0.180785659533216</c:v>
                  </c:pt>
                </c:numCache>
              </c:numRef>
            </c:plus>
            <c:minus>
              <c:numRef>
                <c:f>Treated!$AM$55:$AN$55</c:f>
                <c:numCache>
                  <c:formatCode>General</c:formatCode>
                  <c:ptCount val="2"/>
                  <c:pt idx="0">
                    <c:v>0.150191942173496</c:v>
                  </c:pt>
                  <c:pt idx="1">
                    <c:v>0.18078565953321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Treated!$BS$43:$BT$43</c:f>
              <c:strCache>
                <c:ptCount val="2"/>
                <c:pt idx="0">
                  <c:v>BT549</c:v>
                </c:pt>
                <c:pt idx="1">
                  <c:v>MDA468</c:v>
                </c:pt>
              </c:strCache>
            </c:strRef>
          </c:cat>
          <c:val>
            <c:numRef>
              <c:f>Treated!$BS$46:$BT$46</c:f>
              <c:numCache>
                <c:formatCode>General</c:formatCode>
                <c:ptCount val="2"/>
                <c:pt idx="0">
                  <c:v>0.8356075646124</c:v>
                </c:pt>
                <c:pt idx="1">
                  <c:v>1.2978092216603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7E8C-6149-97D8-5351880A8F6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879375152"/>
        <c:axId val="-544741536"/>
      </c:barChart>
      <c:catAx>
        <c:axId val="-879375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4741536"/>
        <c:crosses val="autoZero"/>
        <c:auto val="1"/>
        <c:lblAlgn val="ctr"/>
        <c:lblOffset val="100"/>
        <c:noMultiLvlLbl val="0"/>
      </c:catAx>
      <c:valAx>
        <c:axId val="-544741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879375152"/>
        <c:crosses val="autoZero"/>
        <c:crossBetween val="between"/>
        <c:majorUnit val="0.5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K$29</c:f>
              <c:strCache>
                <c:ptCount val="1"/>
                <c:pt idx="0">
                  <c:v>relative to GAPDH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numRef>
              <c:f>Sheet1!$L$28:$O$28</c:f>
              <c:numCache>
                <c:formatCode>General</c:formatCode>
                <c:ptCount val="4"/>
                <c:pt idx="0">
                  <c:v>0.0</c:v>
                </c:pt>
                <c:pt idx="1">
                  <c:v>30.0</c:v>
                </c:pt>
                <c:pt idx="2">
                  <c:v>0.0</c:v>
                </c:pt>
                <c:pt idx="3">
                  <c:v>30.0</c:v>
                </c:pt>
              </c:numCache>
            </c:numRef>
          </c:cat>
          <c:val>
            <c:numRef>
              <c:f>Sheet1!$L$29:$O$29</c:f>
              <c:numCache>
                <c:formatCode>General</c:formatCode>
                <c:ptCount val="4"/>
                <c:pt idx="0">
                  <c:v>0.00327862709832134</c:v>
                </c:pt>
                <c:pt idx="1">
                  <c:v>0.00165678409487269</c:v>
                </c:pt>
                <c:pt idx="2">
                  <c:v>0.00212865497076023</c:v>
                </c:pt>
                <c:pt idx="3">
                  <c:v>0.001786122542295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505-4749-B890-EEB95DA697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544606160"/>
        <c:axId val="-544507344"/>
      </c:barChart>
      <c:catAx>
        <c:axId val="-5446061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544507344"/>
        <c:crosses val="autoZero"/>
        <c:auto val="1"/>
        <c:lblAlgn val="ctr"/>
        <c:lblOffset val="100"/>
        <c:noMultiLvlLbl val="0"/>
      </c:catAx>
      <c:valAx>
        <c:axId val="-544507344"/>
        <c:scaling>
          <c:orientation val="minMax"/>
        </c:scaling>
        <c:delete val="1"/>
        <c:axPos val="l"/>
        <c:numFmt formatCode="General" sourceLinked="1"/>
        <c:majorTickMark val="none"/>
        <c:minorTickMark val="none"/>
        <c:tickLblPos val="nextTo"/>
        <c:crossAx val="-5446061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3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32906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11587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90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90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14978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8233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4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48434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6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8104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261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02512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4287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433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6603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6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8BB7C9-AF55-084E-A904-504F46138468}" type="datetimeFigureOut">
              <a:rPr lang="en-US" smtClean="0"/>
              <a:t>5/9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40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40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CDB64F-9AB8-7940-97AB-19F528CED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313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3.tiff"/><Relationship Id="rId12" Type="http://schemas.openxmlformats.org/officeDocument/2006/relationships/image" Target="../media/image4.tiff"/><Relationship Id="rId13" Type="http://schemas.openxmlformats.org/officeDocument/2006/relationships/image" Target="../media/image5.tiff"/><Relationship Id="rId14" Type="http://schemas.openxmlformats.org/officeDocument/2006/relationships/image" Target="../media/image6.tiff"/><Relationship Id="rId15" Type="http://schemas.openxmlformats.org/officeDocument/2006/relationships/image" Target="../media/image7.tiff"/><Relationship Id="rId16" Type="http://schemas.openxmlformats.org/officeDocument/2006/relationships/chart" Target="../charts/chart8.xml"/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8" Type="http://schemas.openxmlformats.org/officeDocument/2006/relationships/chart" Target="../charts/chart7.xml"/><Relationship Id="rId9" Type="http://schemas.openxmlformats.org/officeDocument/2006/relationships/image" Target="../media/image1.jpg"/><Relationship Id="rId10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44292312"/>
              </p:ext>
            </p:extLst>
          </p:nvPr>
        </p:nvGraphicFramePr>
        <p:xfrm>
          <a:off x="1581593" y="170768"/>
          <a:ext cx="2187660" cy="14018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9880819"/>
              </p:ext>
            </p:extLst>
          </p:nvPr>
        </p:nvGraphicFramePr>
        <p:xfrm>
          <a:off x="1564145" y="1492703"/>
          <a:ext cx="2153682" cy="125704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1288355"/>
              </p:ext>
            </p:extLst>
          </p:nvPr>
        </p:nvGraphicFramePr>
        <p:xfrm>
          <a:off x="1631850" y="2733894"/>
          <a:ext cx="2119871" cy="140040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992766"/>
              </p:ext>
            </p:extLst>
          </p:nvPr>
        </p:nvGraphicFramePr>
        <p:xfrm>
          <a:off x="1564145" y="4091616"/>
          <a:ext cx="2187576" cy="1354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Chart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4141306"/>
              </p:ext>
            </p:extLst>
          </p:nvPr>
        </p:nvGraphicFramePr>
        <p:xfrm>
          <a:off x="1507161" y="5446060"/>
          <a:ext cx="2210666" cy="129607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6" name="Chart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6191980"/>
              </p:ext>
            </p:extLst>
          </p:nvPr>
        </p:nvGraphicFramePr>
        <p:xfrm>
          <a:off x="1543390" y="7882937"/>
          <a:ext cx="2210666" cy="126106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7" name="Chart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3046774"/>
              </p:ext>
            </p:extLst>
          </p:nvPr>
        </p:nvGraphicFramePr>
        <p:xfrm>
          <a:off x="1597955" y="6712032"/>
          <a:ext cx="2094307" cy="126095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4" name="TextBox 3"/>
          <p:cNvSpPr txBox="1"/>
          <p:nvPr/>
        </p:nvSpPr>
        <p:spPr>
          <a:xfrm rot="16200000">
            <a:off x="-155843" y="4215683"/>
            <a:ext cx="306449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Protein levels relative to vehicle control</a:t>
            </a:r>
          </a:p>
        </p:txBody>
      </p:sp>
      <p:grpSp>
        <p:nvGrpSpPr>
          <p:cNvPr id="20" name="Group 19"/>
          <p:cNvGrpSpPr/>
          <p:nvPr/>
        </p:nvGrpSpPr>
        <p:grpSpPr>
          <a:xfrm>
            <a:off x="0" y="966207"/>
            <a:ext cx="1489318" cy="830997"/>
            <a:chOff x="2691209" y="305054"/>
            <a:chExt cx="1489318" cy="83099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47" t="90921" r="75326" b="4742"/>
            <a:stretch/>
          </p:blipFill>
          <p:spPr>
            <a:xfrm>
              <a:off x="2727715" y="358987"/>
              <a:ext cx="178045" cy="204852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210" t="90153" r="55456" b="4433"/>
            <a:stretch/>
          </p:blipFill>
          <p:spPr>
            <a:xfrm>
              <a:off x="2691209" y="563839"/>
              <a:ext cx="234870" cy="255734"/>
            </a:xfrm>
            <a:prstGeom prst="rect">
              <a:avLst/>
            </a:prstGeom>
          </p:spPr>
        </p:pic>
        <p:pic>
          <p:nvPicPr>
            <p:cNvPr id="19" name="Picture 18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1498" t="91222" r="35809" b="4668"/>
            <a:stretch/>
          </p:blipFill>
          <p:spPr>
            <a:xfrm>
              <a:off x="2736427" y="882818"/>
              <a:ext cx="189652" cy="194142"/>
            </a:xfrm>
            <a:prstGeom prst="rect">
              <a:avLst/>
            </a:prstGeom>
          </p:spPr>
        </p:pic>
        <p:sp>
          <p:nvSpPr>
            <p:cNvPr id="5" name="TextBox 4"/>
            <p:cNvSpPr txBox="1"/>
            <p:nvPr/>
          </p:nvSpPr>
          <p:spPr>
            <a:xfrm>
              <a:off x="2851573" y="305054"/>
              <a:ext cx="132895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dirty="0"/>
                <a:t>MEK Inhibitor</a:t>
              </a:r>
            </a:p>
            <a:p>
              <a:r>
                <a:rPr lang="en-US" sz="1600" dirty="0" err="1"/>
                <a:t>IKK</a:t>
              </a:r>
              <a:r>
                <a:rPr lang="en-US" sz="1600" dirty="0" err="1">
                  <a:latin typeface="Symbol" charset="2"/>
                  <a:ea typeface="Symbol" charset="2"/>
                  <a:cs typeface="Symbol" charset="2"/>
                </a:rPr>
                <a:t>b</a:t>
              </a:r>
              <a:r>
                <a:rPr lang="en-US" sz="1600" dirty="0"/>
                <a:t> Inhibitor</a:t>
              </a:r>
            </a:p>
            <a:p>
              <a:r>
                <a:rPr lang="en-US" sz="1600" dirty="0" err="1"/>
                <a:t>IKK</a:t>
              </a:r>
              <a:r>
                <a:rPr lang="en-US" sz="1600" dirty="0" err="1">
                  <a:latin typeface="Symbol" charset="2"/>
                  <a:ea typeface="Symbol" charset="2"/>
                  <a:cs typeface="Symbol" charset="2"/>
                </a:rPr>
                <a:t>e</a:t>
              </a:r>
              <a:r>
                <a:rPr lang="en-US" sz="1600" dirty="0"/>
                <a:t> Inhibitor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3838211" y="318597"/>
            <a:ext cx="2746137" cy="1528566"/>
            <a:chOff x="0" y="1506615"/>
            <a:chExt cx="3089703" cy="1779840"/>
          </a:xfrm>
        </p:grpSpPr>
        <p:pic>
          <p:nvPicPr>
            <p:cNvPr id="22" name="Picture 21"/>
            <p:cNvPicPr>
              <a:picLocks noChangeAspect="1"/>
            </p:cNvPicPr>
            <p:nvPr/>
          </p:nvPicPr>
          <p:blipFill rotWithShape="1">
            <a:blip r:embed="rId10"/>
            <a:srcRect l="5081" t="-6004" r="56766"/>
            <a:stretch/>
          </p:blipFill>
          <p:spPr>
            <a:xfrm>
              <a:off x="1107970" y="2090835"/>
              <a:ext cx="909957" cy="404181"/>
            </a:xfrm>
            <a:prstGeom prst="rect">
              <a:avLst/>
            </a:prstGeom>
          </p:spPr>
        </p:pic>
        <p:sp>
          <p:nvSpPr>
            <p:cNvPr id="23" name="TextBox 22"/>
            <p:cNvSpPr txBox="1"/>
            <p:nvPr/>
          </p:nvSpPr>
          <p:spPr>
            <a:xfrm>
              <a:off x="239655" y="2186055"/>
              <a:ext cx="861107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P-ERK1/2</a:t>
              </a:r>
            </a:p>
          </p:txBody>
        </p:sp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11"/>
            <a:srcRect l="4720" t="-6762" r="57111"/>
            <a:stretch/>
          </p:blipFill>
          <p:spPr>
            <a:xfrm>
              <a:off x="1110585" y="2493832"/>
              <a:ext cx="909958" cy="389525"/>
            </a:xfrm>
            <a:prstGeom prst="rect">
              <a:avLst/>
            </a:prstGeom>
          </p:spPr>
        </p:pic>
        <p:sp>
          <p:nvSpPr>
            <p:cNvPr id="25" name="TextBox 24"/>
            <p:cNvSpPr txBox="1"/>
            <p:nvPr/>
          </p:nvSpPr>
          <p:spPr>
            <a:xfrm>
              <a:off x="1158399" y="1780997"/>
              <a:ext cx="238643" cy="3225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562948" y="1777742"/>
              <a:ext cx="534202" cy="3225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/>
                <a:t>30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0" y="2575580"/>
              <a:ext cx="1116760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Total ERK1/2</a:t>
              </a:r>
              <a:endParaRPr lang="en-US" sz="1200" dirty="0"/>
            </a:p>
          </p:txBody>
        </p:sp>
        <p:pic>
          <p:nvPicPr>
            <p:cNvPr id="28" name="Picture 27"/>
            <p:cNvPicPr>
              <a:picLocks noChangeAspect="1"/>
            </p:cNvPicPr>
            <p:nvPr/>
          </p:nvPicPr>
          <p:blipFill rotWithShape="1">
            <a:blip r:embed="rId12"/>
            <a:srcRect t="13580" r="59940"/>
            <a:stretch/>
          </p:blipFill>
          <p:spPr>
            <a:xfrm>
              <a:off x="1107970" y="2911429"/>
              <a:ext cx="909957" cy="309836"/>
            </a:xfrm>
            <a:prstGeom prst="rect">
              <a:avLst/>
            </a:prstGeom>
          </p:spPr>
        </p:pic>
        <p:sp>
          <p:nvSpPr>
            <p:cNvPr id="29" name="TextBox 28"/>
            <p:cNvSpPr txBox="1"/>
            <p:nvPr/>
          </p:nvSpPr>
          <p:spPr>
            <a:xfrm>
              <a:off x="328961" y="2963921"/>
              <a:ext cx="721022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GAPDH</a:t>
              </a:r>
            </a:p>
          </p:txBody>
        </p:sp>
        <p:pic>
          <p:nvPicPr>
            <p:cNvPr id="30" name="Picture 29"/>
            <p:cNvPicPr>
              <a:picLocks noChangeAspect="1"/>
            </p:cNvPicPr>
            <p:nvPr/>
          </p:nvPicPr>
          <p:blipFill rotWithShape="1">
            <a:blip r:embed="rId13"/>
            <a:srcRect l="5943" t="4483" r="58041" b="12075"/>
            <a:stretch/>
          </p:blipFill>
          <p:spPr>
            <a:xfrm>
              <a:off x="2092877" y="2114506"/>
              <a:ext cx="990547" cy="380510"/>
            </a:xfrm>
            <a:prstGeom prst="rect">
              <a:avLst/>
            </a:prstGeom>
          </p:spPr>
        </p:pic>
        <p:pic>
          <p:nvPicPr>
            <p:cNvPr id="31" name="Picture 30"/>
            <p:cNvPicPr>
              <a:picLocks noChangeAspect="1"/>
            </p:cNvPicPr>
            <p:nvPr/>
          </p:nvPicPr>
          <p:blipFill rotWithShape="1">
            <a:blip r:embed="rId14"/>
            <a:srcRect l="3265" t="12409" r="59693" b="-1"/>
            <a:stretch/>
          </p:blipFill>
          <p:spPr>
            <a:xfrm>
              <a:off x="2088248" y="2530860"/>
              <a:ext cx="988245" cy="352497"/>
            </a:xfrm>
            <a:prstGeom prst="rect">
              <a:avLst/>
            </a:prstGeom>
          </p:spPr>
        </p:pic>
        <p:sp>
          <p:nvSpPr>
            <p:cNvPr id="32" name="TextBox 31"/>
            <p:cNvSpPr txBox="1"/>
            <p:nvPr/>
          </p:nvSpPr>
          <p:spPr>
            <a:xfrm>
              <a:off x="2230516" y="1761279"/>
              <a:ext cx="295523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2706426" y="1761279"/>
              <a:ext cx="383277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/>
                <a:t>30</a:t>
              </a:r>
            </a:p>
          </p:txBody>
        </p:sp>
        <p:pic>
          <p:nvPicPr>
            <p:cNvPr id="34" name="Picture 33"/>
            <p:cNvPicPr>
              <a:picLocks noChangeAspect="1"/>
            </p:cNvPicPr>
            <p:nvPr/>
          </p:nvPicPr>
          <p:blipFill rotWithShape="1">
            <a:blip r:embed="rId15"/>
            <a:srcRect t="15593" r="58592"/>
            <a:stretch/>
          </p:blipFill>
          <p:spPr>
            <a:xfrm>
              <a:off x="2088248" y="2911429"/>
              <a:ext cx="988245" cy="309836"/>
            </a:xfrm>
            <a:prstGeom prst="rect">
              <a:avLst/>
            </a:prstGeom>
          </p:spPr>
        </p:pic>
        <p:sp>
          <p:nvSpPr>
            <p:cNvPr id="35" name="TextBox 34"/>
            <p:cNvSpPr txBox="1"/>
            <p:nvPr/>
          </p:nvSpPr>
          <p:spPr>
            <a:xfrm>
              <a:off x="1073601" y="1506615"/>
              <a:ext cx="825768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MDA468</a:t>
              </a: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345948" y="1507145"/>
              <a:ext cx="649584" cy="32253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BT549</a:t>
              </a:r>
            </a:p>
          </p:txBody>
        </p:sp>
      </p:grpSp>
      <p:sp>
        <p:nvSpPr>
          <p:cNvPr id="81" name="TextBox 80"/>
          <p:cNvSpPr txBox="1"/>
          <p:nvPr/>
        </p:nvSpPr>
        <p:spPr>
          <a:xfrm>
            <a:off x="0" y="301099"/>
            <a:ext cx="2824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a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4096325" y="301099"/>
            <a:ext cx="2924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b</a:t>
            </a:r>
          </a:p>
        </p:txBody>
      </p:sp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xmlns="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69807175"/>
              </p:ext>
            </p:extLst>
          </p:nvPr>
        </p:nvGraphicFramePr>
        <p:xfrm>
          <a:off x="4868332" y="1879600"/>
          <a:ext cx="1735667" cy="11599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64DA318B-CB70-0546-9EBD-17959881DF5E}"/>
              </a:ext>
            </a:extLst>
          </p:cNvPr>
          <p:cNvSpPr txBox="1"/>
          <p:nvPr/>
        </p:nvSpPr>
        <p:spPr>
          <a:xfrm>
            <a:off x="5004098" y="2977131"/>
            <a:ext cx="733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DA468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xmlns="" id="{35FAC759-AB66-2243-A7DA-74F97E5DECA6}"/>
              </a:ext>
            </a:extLst>
          </p:cNvPr>
          <p:cNvSpPr txBox="1"/>
          <p:nvPr/>
        </p:nvSpPr>
        <p:spPr>
          <a:xfrm>
            <a:off x="5830161" y="2969119"/>
            <a:ext cx="57735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BT549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xmlns="" id="{E40798AE-9086-314E-B109-5D49FC3B843A}"/>
              </a:ext>
            </a:extLst>
          </p:cNvPr>
          <p:cNvCxnSpPr/>
          <p:nvPr/>
        </p:nvCxnSpPr>
        <p:spPr>
          <a:xfrm>
            <a:off x="5147733" y="2997200"/>
            <a:ext cx="4572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xmlns="" id="{44FF5735-B6B5-8B42-BD4C-79D016BD68EB}"/>
              </a:ext>
            </a:extLst>
          </p:cNvPr>
          <p:cNvCxnSpPr/>
          <p:nvPr/>
        </p:nvCxnSpPr>
        <p:spPr>
          <a:xfrm>
            <a:off x="5901266" y="2988733"/>
            <a:ext cx="45720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xmlns="" id="{31D78092-EB39-F348-B819-E443060BDF36}"/>
              </a:ext>
            </a:extLst>
          </p:cNvPr>
          <p:cNvSpPr/>
          <p:nvPr/>
        </p:nvSpPr>
        <p:spPr>
          <a:xfrm>
            <a:off x="4969933" y="2006601"/>
            <a:ext cx="1600200" cy="736600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453A0A6A-84B7-834B-B0F3-4B8D471F841C}"/>
              </a:ext>
            </a:extLst>
          </p:cNvPr>
          <p:cNvSpPr txBox="1"/>
          <p:nvPr/>
        </p:nvSpPr>
        <p:spPr>
          <a:xfrm>
            <a:off x="4766200" y="2620109"/>
            <a:ext cx="21210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0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xmlns="" id="{088F6E07-18FC-6E41-8E17-A748A3EE20F8}"/>
              </a:ext>
            </a:extLst>
          </p:cNvPr>
          <p:cNvSpPr txBox="1"/>
          <p:nvPr/>
        </p:nvSpPr>
        <p:spPr>
          <a:xfrm>
            <a:off x="4706932" y="2328010"/>
            <a:ext cx="34766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0.5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xmlns="" id="{2072EE9F-9BC0-7342-B804-0DEA27BA7AC0}"/>
              </a:ext>
            </a:extLst>
          </p:cNvPr>
          <p:cNvSpPr txBox="1"/>
          <p:nvPr/>
        </p:nvSpPr>
        <p:spPr>
          <a:xfrm>
            <a:off x="4706931" y="2035910"/>
            <a:ext cx="3307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.0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4EEF0BB1-95AA-0045-81E0-D96835250965}"/>
              </a:ext>
            </a:extLst>
          </p:cNvPr>
          <p:cNvSpPr txBox="1"/>
          <p:nvPr/>
        </p:nvSpPr>
        <p:spPr>
          <a:xfrm rot="16200000">
            <a:off x="4039826" y="2201039"/>
            <a:ext cx="11476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dirty="0"/>
              <a:t>Relative expression </a:t>
            </a:r>
            <a:r>
              <a:rPr lang="en-US" sz="900" dirty="0" err="1"/>
              <a:t>phospho</a:t>
            </a:r>
            <a:r>
              <a:rPr lang="en-US" sz="900" dirty="0"/>
              <a:t>-ERK</a:t>
            </a:r>
          </a:p>
        </p:txBody>
      </p:sp>
    </p:spTree>
    <p:extLst>
      <p:ext uri="{BB962C8B-B14F-4D97-AF65-F5344CB8AC3E}">
        <p14:creationId xmlns:p14="http://schemas.microsoft.com/office/powerpoint/2010/main" val="8811154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56</TotalTime>
  <Words>43</Words>
  <Application>Microsoft Macintosh PowerPoint</Application>
  <PresentationFormat>On-screen Show (4:3)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Calibri</vt:lpstr>
      <vt:lpstr>Symbol</vt:lpstr>
      <vt:lpstr>Arial</vt:lpstr>
      <vt:lpstr>Office Theme</vt:lpstr>
      <vt:lpstr>PowerPoint Presentation</vt:lpstr>
    </vt:vector>
  </TitlesOfParts>
  <Company>NIH</Company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Annunziata</dc:creator>
  <cp:lastModifiedBy>Carrie House</cp:lastModifiedBy>
  <cp:revision>358</cp:revision>
  <dcterms:created xsi:type="dcterms:W3CDTF">2016-03-03T15:39:21Z</dcterms:created>
  <dcterms:modified xsi:type="dcterms:W3CDTF">2018-05-09T15:05:24Z</dcterms:modified>
</cp:coreProperties>
</file>